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32" r:id="rId1"/>
  </p:sldMasterIdLst>
  <p:sldIdLst>
    <p:sldId id="258" r:id="rId2"/>
    <p:sldId id="271" r:id="rId3"/>
    <p:sldId id="273" r:id="rId4"/>
    <p:sldId id="274" r:id="rId5"/>
    <p:sldId id="272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771" autoAdjust="0"/>
    <p:restoredTop sz="96130" autoAdjust="0"/>
  </p:normalViewPr>
  <p:slideViewPr>
    <p:cSldViewPr snapToGrid="0">
      <p:cViewPr>
        <p:scale>
          <a:sx n="59" d="100"/>
          <a:sy n="59" d="100"/>
        </p:scale>
        <p:origin x="2088" y="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F4BD0-84B3-4930-992F-A94F70AB0B98}" type="datetimeFigureOut">
              <a:rPr lang="zh-CN" altLang="en-US" smtClean="0"/>
              <a:t>2019/3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1D7611-A16D-464B-B90C-A5BB54239F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00719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F4BD0-84B3-4930-992F-A94F70AB0B98}" type="datetimeFigureOut">
              <a:rPr lang="zh-CN" altLang="en-US" smtClean="0"/>
              <a:t>2019/3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1D7611-A16D-464B-B90C-A5BB54239F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797018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F4BD0-84B3-4930-992F-A94F70AB0B98}" type="datetimeFigureOut">
              <a:rPr lang="zh-CN" altLang="en-US" smtClean="0"/>
              <a:t>2019/3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1D7611-A16D-464B-B90C-A5BB54239F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693808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F4BD0-84B3-4930-992F-A94F70AB0B98}" type="datetimeFigureOut">
              <a:rPr lang="zh-CN" altLang="en-US" smtClean="0"/>
              <a:t>2019/3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1D7611-A16D-464B-B90C-A5BB54239F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34975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F4BD0-84B3-4930-992F-A94F70AB0B98}" type="datetimeFigureOut">
              <a:rPr lang="zh-CN" altLang="en-US" smtClean="0"/>
              <a:t>2019/3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1D7611-A16D-464B-B90C-A5BB54239F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46528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F4BD0-84B3-4930-992F-A94F70AB0B98}" type="datetimeFigureOut">
              <a:rPr lang="zh-CN" altLang="en-US" smtClean="0"/>
              <a:t>2019/3/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1D7611-A16D-464B-B90C-A5BB54239F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72336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F4BD0-84B3-4930-992F-A94F70AB0B98}" type="datetimeFigureOut">
              <a:rPr lang="zh-CN" altLang="en-US" smtClean="0"/>
              <a:t>2019/3/4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1D7611-A16D-464B-B90C-A5BB54239F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53881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F4BD0-84B3-4930-992F-A94F70AB0B98}" type="datetimeFigureOut">
              <a:rPr lang="zh-CN" altLang="en-US" smtClean="0"/>
              <a:t>2019/3/4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1D7611-A16D-464B-B90C-A5BB54239F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72062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F4BD0-84B3-4930-992F-A94F70AB0B98}" type="datetimeFigureOut">
              <a:rPr lang="zh-CN" altLang="en-US" smtClean="0"/>
              <a:t>2019/3/4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1D7611-A16D-464B-B90C-A5BB54239F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92480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F4BD0-84B3-4930-992F-A94F70AB0B98}" type="datetimeFigureOut">
              <a:rPr lang="zh-CN" altLang="en-US" smtClean="0"/>
              <a:t>2019/3/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1D7611-A16D-464B-B90C-A5BB54239F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957709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7F4BD0-84B3-4930-992F-A94F70AB0B98}" type="datetimeFigureOut">
              <a:rPr lang="zh-CN" altLang="en-US" smtClean="0"/>
              <a:t>2019/3/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1D7611-A16D-464B-B90C-A5BB54239F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502998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7F4BD0-84B3-4930-992F-A94F70AB0B98}" type="datetimeFigureOut">
              <a:rPr lang="zh-CN" altLang="en-US" smtClean="0"/>
              <a:t>2019/3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1D7611-A16D-464B-B90C-A5BB54239F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92839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15681" y="627991"/>
            <a:ext cx="603100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b="1" kern="100" dirty="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Supplementary Figure S1 </a:t>
            </a:r>
            <a:r>
              <a:rPr lang="en-US" altLang="zh-CN" kern="100" dirty="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Data normalization of lipids by negative ion mode</a:t>
            </a:r>
            <a:endParaRPr lang="zh-CN" altLang="zh-CN" kern="100" dirty="0">
              <a:latin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81" y="1393371"/>
            <a:ext cx="6858000" cy="81642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273504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15681" y="627991"/>
            <a:ext cx="603100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b="1" kern="100" dirty="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Supplementary Figure S2 </a:t>
            </a:r>
            <a:r>
              <a:rPr lang="en-US" altLang="zh-CN" kern="100" dirty="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Data normalization of lipids by positive ion mode</a:t>
            </a:r>
            <a:endParaRPr lang="zh-CN" altLang="zh-CN" kern="100" dirty="0">
              <a:latin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81" y="1432560"/>
            <a:ext cx="6858000" cy="81642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44867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>
            <a:extLst>
              <a:ext uri="{FF2B5EF4-FFF2-40B4-BE49-F238E27FC236}">
                <a16:creationId xmlns:a16="http://schemas.microsoft.com/office/drawing/2014/main" id="{C57CD501-6EBA-4A65-A12E-D3F7DC007D5C}"/>
              </a:ext>
            </a:extLst>
          </p:cNvPr>
          <p:cNvSpPr/>
          <p:nvPr/>
        </p:nvSpPr>
        <p:spPr>
          <a:xfrm>
            <a:off x="0" y="208891"/>
            <a:ext cx="603100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b="1" kern="100" dirty="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Supplementary Figure S3 </a:t>
            </a:r>
            <a:r>
              <a:rPr lang="en-US" altLang="zh-CN" kern="100" dirty="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Heatmap of all circulating lipids in negative ion mode</a:t>
            </a:r>
            <a:endParaRPr lang="zh-CN" altLang="zh-CN" kern="100" dirty="0">
              <a:latin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4292596A-F5E8-4E06-869B-2645C4B0B2C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370" r="6334"/>
          <a:stretch/>
        </p:blipFill>
        <p:spPr>
          <a:xfrm>
            <a:off x="342900" y="1106504"/>
            <a:ext cx="5781275" cy="6025883"/>
          </a:xfrm>
          <a:prstGeom prst="rect">
            <a:avLst/>
          </a:prstGeom>
        </p:spPr>
      </p:pic>
      <p:cxnSp>
        <p:nvCxnSpPr>
          <p:cNvPr id="5" name="直接连接符 4">
            <a:extLst>
              <a:ext uri="{FF2B5EF4-FFF2-40B4-BE49-F238E27FC236}">
                <a16:creationId xmlns:a16="http://schemas.microsoft.com/office/drawing/2014/main" id="{90B7E115-F033-4EFD-9B6A-7E9DF296CCF6}"/>
              </a:ext>
            </a:extLst>
          </p:cNvPr>
          <p:cNvCxnSpPr>
            <a:cxnSpLocks/>
          </p:cNvCxnSpPr>
          <p:nvPr/>
        </p:nvCxnSpPr>
        <p:spPr>
          <a:xfrm>
            <a:off x="868296" y="1042373"/>
            <a:ext cx="1376284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id="{8959C094-8A81-40D2-92A8-87019AC2B326}"/>
              </a:ext>
            </a:extLst>
          </p:cNvPr>
          <p:cNvCxnSpPr>
            <a:cxnSpLocks/>
          </p:cNvCxnSpPr>
          <p:nvPr/>
        </p:nvCxnSpPr>
        <p:spPr>
          <a:xfrm>
            <a:off x="2244580" y="1042373"/>
            <a:ext cx="1408705" cy="0"/>
          </a:xfrm>
          <a:prstGeom prst="line">
            <a:avLst/>
          </a:prstGeom>
          <a:ln w="38100">
            <a:solidFill>
              <a:srgbClr val="FFA04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接连接符 6">
            <a:extLst>
              <a:ext uri="{FF2B5EF4-FFF2-40B4-BE49-F238E27FC236}">
                <a16:creationId xmlns:a16="http://schemas.microsoft.com/office/drawing/2014/main" id="{C9D3156C-CC10-47DB-80AF-E0A1F10A7316}"/>
              </a:ext>
            </a:extLst>
          </p:cNvPr>
          <p:cNvCxnSpPr>
            <a:cxnSpLocks/>
          </p:cNvCxnSpPr>
          <p:nvPr/>
        </p:nvCxnSpPr>
        <p:spPr>
          <a:xfrm>
            <a:off x="3653285" y="1042373"/>
            <a:ext cx="1425861" cy="0"/>
          </a:xfrm>
          <a:prstGeom prst="line">
            <a:avLst/>
          </a:prstGeom>
          <a:ln w="38100">
            <a:solidFill>
              <a:srgbClr val="80808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1" name="组合 10">
            <a:extLst>
              <a:ext uri="{FF2B5EF4-FFF2-40B4-BE49-F238E27FC236}">
                <a16:creationId xmlns:a16="http://schemas.microsoft.com/office/drawing/2014/main" id="{5D12C9E5-F254-4E52-8F97-607728DA4449}"/>
              </a:ext>
            </a:extLst>
          </p:cNvPr>
          <p:cNvGrpSpPr/>
          <p:nvPr/>
        </p:nvGrpSpPr>
        <p:grpSpPr>
          <a:xfrm>
            <a:off x="1358201" y="7129753"/>
            <a:ext cx="4141597" cy="253916"/>
            <a:chOff x="1167252" y="7317257"/>
            <a:chExt cx="4141597" cy="253916"/>
          </a:xfrm>
        </p:grpSpPr>
        <p:cxnSp>
          <p:nvCxnSpPr>
            <p:cNvPr id="12" name="直接连接符 11">
              <a:extLst>
                <a:ext uri="{FF2B5EF4-FFF2-40B4-BE49-F238E27FC236}">
                  <a16:creationId xmlns:a16="http://schemas.microsoft.com/office/drawing/2014/main" id="{5F3A7CB5-CFFF-4E5F-BEA9-29FA6BE5FB12}"/>
                </a:ext>
              </a:extLst>
            </p:cNvPr>
            <p:cNvCxnSpPr/>
            <p:nvPr/>
          </p:nvCxnSpPr>
          <p:spPr>
            <a:xfrm flipV="1">
              <a:off x="1167252" y="7448066"/>
              <a:ext cx="180000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直接连接符 12">
              <a:extLst>
                <a:ext uri="{FF2B5EF4-FFF2-40B4-BE49-F238E27FC236}">
                  <a16:creationId xmlns:a16="http://schemas.microsoft.com/office/drawing/2014/main" id="{590F0D22-79DD-4B4F-AEC4-2A7647988EBD}"/>
                </a:ext>
              </a:extLst>
            </p:cNvPr>
            <p:cNvCxnSpPr/>
            <p:nvPr/>
          </p:nvCxnSpPr>
          <p:spPr>
            <a:xfrm flipV="1">
              <a:off x="2753643" y="7448066"/>
              <a:ext cx="180000" cy="0"/>
            </a:xfrm>
            <a:prstGeom prst="line">
              <a:avLst/>
            </a:prstGeom>
            <a:ln w="38100">
              <a:solidFill>
                <a:srgbClr val="FFA04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直接连接符 13">
              <a:extLst>
                <a:ext uri="{FF2B5EF4-FFF2-40B4-BE49-F238E27FC236}">
                  <a16:creationId xmlns:a16="http://schemas.microsoft.com/office/drawing/2014/main" id="{D88B865B-5725-48AF-86E9-9875C7327002}"/>
                </a:ext>
              </a:extLst>
            </p:cNvPr>
            <p:cNvCxnSpPr/>
            <p:nvPr/>
          </p:nvCxnSpPr>
          <p:spPr>
            <a:xfrm flipV="1">
              <a:off x="3910596" y="7448066"/>
              <a:ext cx="180000" cy="0"/>
            </a:xfrm>
            <a:prstGeom prst="line">
              <a:avLst/>
            </a:prstGeom>
            <a:ln w="38100">
              <a:solidFill>
                <a:srgbClr val="80808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D390E0C0-D901-45E3-9519-CE04A66EBF8C}"/>
                </a:ext>
              </a:extLst>
            </p:cNvPr>
            <p:cNvSpPr txBox="1"/>
            <p:nvPr/>
          </p:nvSpPr>
          <p:spPr>
            <a:xfrm>
              <a:off x="1313340" y="7317257"/>
              <a:ext cx="1252165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/>
                <a:t>ICM</a:t>
              </a:r>
              <a:endParaRPr lang="zh-CN" altLang="en-US" sz="1050" dirty="0"/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DC69BDE5-ADAA-41F2-8EEB-C229A63C50C4}"/>
                </a:ext>
              </a:extLst>
            </p:cNvPr>
            <p:cNvSpPr txBox="1"/>
            <p:nvPr/>
          </p:nvSpPr>
          <p:spPr>
            <a:xfrm>
              <a:off x="2899731" y="7317257"/>
              <a:ext cx="1252165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/>
                <a:t>IHD</a:t>
              </a:r>
              <a:endParaRPr lang="zh-CN" altLang="en-US" sz="1050" dirty="0"/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E382E0FE-CBDA-4C42-9D58-E9FE9E60AF30}"/>
                </a:ext>
              </a:extLst>
            </p:cNvPr>
            <p:cNvSpPr txBox="1"/>
            <p:nvPr/>
          </p:nvSpPr>
          <p:spPr>
            <a:xfrm>
              <a:off x="4056684" y="7317257"/>
              <a:ext cx="1252165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/>
                <a:t>Control</a:t>
              </a:r>
              <a:endParaRPr lang="zh-CN" altLang="en-US" sz="1050" dirty="0"/>
            </a:p>
          </p:txBody>
        </p:sp>
      </p:grpSp>
    </p:spTree>
    <p:extLst>
      <p:ext uri="{BB962C8B-B14F-4D97-AF65-F5344CB8AC3E}">
        <p14:creationId xmlns:p14="http://schemas.microsoft.com/office/powerpoint/2010/main" val="116228625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>
            <a:extLst>
              <a:ext uri="{FF2B5EF4-FFF2-40B4-BE49-F238E27FC236}">
                <a16:creationId xmlns:a16="http://schemas.microsoft.com/office/drawing/2014/main" id="{C57CD501-6EBA-4A65-A12E-D3F7DC007D5C}"/>
              </a:ext>
            </a:extLst>
          </p:cNvPr>
          <p:cNvSpPr/>
          <p:nvPr/>
        </p:nvSpPr>
        <p:spPr>
          <a:xfrm>
            <a:off x="0" y="208891"/>
            <a:ext cx="603100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b="1" kern="100" dirty="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Supplementary Figure S4 </a:t>
            </a:r>
            <a:r>
              <a:rPr lang="en-US" altLang="zh-CN" kern="100" dirty="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Heatmap of all circulating lipids in positive ion mode</a:t>
            </a:r>
            <a:endParaRPr lang="zh-CN" altLang="zh-CN" kern="100" dirty="0">
              <a:latin typeface="等线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5" name="直接连接符 4">
            <a:extLst>
              <a:ext uri="{FF2B5EF4-FFF2-40B4-BE49-F238E27FC236}">
                <a16:creationId xmlns:a16="http://schemas.microsoft.com/office/drawing/2014/main" id="{90B7E115-F033-4EFD-9B6A-7E9DF296CCF6}"/>
              </a:ext>
            </a:extLst>
          </p:cNvPr>
          <p:cNvCxnSpPr>
            <a:cxnSpLocks/>
          </p:cNvCxnSpPr>
          <p:nvPr/>
        </p:nvCxnSpPr>
        <p:spPr>
          <a:xfrm>
            <a:off x="868296" y="1042373"/>
            <a:ext cx="1376284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id="{8959C094-8A81-40D2-92A8-87019AC2B326}"/>
              </a:ext>
            </a:extLst>
          </p:cNvPr>
          <p:cNvCxnSpPr>
            <a:cxnSpLocks/>
          </p:cNvCxnSpPr>
          <p:nvPr/>
        </p:nvCxnSpPr>
        <p:spPr>
          <a:xfrm>
            <a:off x="2244580" y="1042373"/>
            <a:ext cx="1408705" cy="0"/>
          </a:xfrm>
          <a:prstGeom prst="line">
            <a:avLst/>
          </a:prstGeom>
          <a:ln w="38100">
            <a:solidFill>
              <a:srgbClr val="FFA04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接连接符 6">
            <a:extLst>
              <a:ext uri="{FF2B5EF4-FFF2-40B4-BE49-F238E27FC236}">
                <a16:creationId xmlns:a16="http://schemas.microsoft.com/office/drawing/2014/main" id="{C9D3156C-CC10-47DB-80AF-E0A1F10A7316}"/>
              </a:ext>
            </a:extLst>
          </p:cNvPr>
          <p:cNvCxnSpPr>
            <a:cxnSpLocks/>
          </p:cNvCxnSpPr>
          <p:nvPr/>
        </p:nvCxnSpPr>
        <p:spPr>
          <a:xfrm>
            <a:off x="3653285" y="1042373"/>
            <a:ext cx="1425861" cy="0"/>
          </a:xfrm>
          <a:prstGeom prst="line">
            <a:avLst/>
          </a:prstGeom>
          <a:ln w="38100">
            <a:solidFill>
              <a:srgbClr val="80808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1" name="组合 10">
            <a:extLst>
              <a:ext uri="{FF2B5EF4-FFF2-40B4-BE49-F238E27FC236}">
                <a16:creationId xmlns:a16="http://schemas.microsoft.com/office/drawing/2014/main" id="{5D12C9E5-F254-4E52-8F97-607728DA4449}"/>
              </a:ext>
            </a:extLst>
          </p:cNvPr>
          <p:cNvGrpSpPr/>
          <p:nvPr/>
        </p:nvGrpSpPr>
        <p:grpSpPr>
          <a:xfrm>
            <a:off x="1358201" y="7129753"/>
            <a:ext cx="4141597" cy="253916"/>
            <a:chOff x="1167252" y="7317257"/>
            <a:chExt cx="4141597" cy="253916"/>
          </a:xfrm>
        </p:grpSpPr>
        <p:cxnSp>
          <p:nvCxnSpPr>
            <p:cNvPr id="12" name="直接连接符 11">
              <a:extLst>
                <a:ext uri="{FF2B5EF4-FFF2-40B4-BE49-F238E27FC236}">
                  <a16:creationId xmlns:a16="http://schemas.microsoft.com/office/drawing/2014/main" id="{5F3A7CB5-CFFF-4E5F-BEA9-29FA6BE5FB12}"/>
                </a:ext>
              </a:extLst>
            </p:cNvPr>
            <p:cNvCxnSpPr/>
            <p:nvPr/>
          </p:nvCxnSpPr>
          <p:spPr>
            <a:xfrm flipV="1">
              <a:off x="1167252" y="7448066"/>
              <a:ext cx="180000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直接连接符 12">
              <a:extLst>
                <a:ext uri="{FF2B5EF4-FFF2-40B4-BE49-F238E27FC236}">
                  <a16:creationId xmlns:a16="http://schemas.microsoft.com/office/drawing/2014/main" id="{590F0D22-79DD-4B4F-AEC4-2A7647988EBD}"/>
                </a:ext>
              </a:extLst>
            </p:cNvPr>
            <p:cNvCxnSpPr/>
            <p:nvPr/>
          </p:nvCxnSpPr>
          <p:spPr>
            <a:xfrm flipV="1">
              <a:off x="2753643" y="7448066"/>
              <a:ext cx="180000" cy="0"/>
            </a:xfrm>
            <a:prstGeom prst="line">
              <a:avLst/>
            </a:prstGeom>
            <a:ln w="38100">
              <a:solidFill>
                <a:srgbClr val="FFA04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直接连接符 13">
              <a:extLst>
                <a:ext uri="{FF2B5EF4-FFF2-40B4-BE49-F238E27FC236}">
                  <a16:creationId xmlns:a16="http://schemas.microsoft.com/office/drawing/2014/main" id="{D88B865B-5725-48AF-86E9-9875C7327002}"/>
                </a:ext>
              </a:extLst>
            </p:cNvPr>
            <p:cNvCxnSpPr/>
            <p:nvPr/>
          </p:nvCxnSpPr>
          <p:spPr>
            <a:xfrm flipV="1">
              <a:off x="3910596" y="7448066"/>
              <a:ext cx="180000" cy="0"/>
            </a:xfrm>
            <a:prstGeom prst="line">
              <a:avLst/>
            </a:prstGeom>
            <a:ln w="38100">
              <a:solidFill>
                <a:srgbClr val="80808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D390E0C0-D901-45E3-9519-CE04A66EBF8C}"/>
                </a:ext>
              </a:extLst>
            </p:cNvPr>
            <p:cNvSpPr txBox="1"/>
            <p:nvPr/>
          </p:nvSpPr>
          <p:spPr>
            <a:xfrm>
              <a:off x="1313340" y="7317257"/>
              <a:ext cx="1252165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/>
                <a:t>ICM</a:t>
              </a:r>
              <a:endParaRPr lang="zh-CN" altLang="en-US" sz="1050" dirty="0"/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DC69BDE5-ADAA-41F2-8EEB-C229A63C50C4}"/>
                </a:ext>
              </a:extLst>
            </p:cNvPr>
            <p:cNvSpPr txBox="1"/>
            <p:nvPr/>
          </p:nvSpPr>
          <p:spPr>
            <a:xfrm>
              <a:off x="2899731" y="7317257"/>
              <a:ext cx="1252165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/>
                <a:t>IHD</a:t>
              </a:r>
              <a:endParaRPr lang="zh-CN" altLang="en-US" sz="1050" dirty="0"/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E382E0FE-CBDA-4C42-9D58-E9FE9E60AF30}"/>
                </a:ext>
              </a:extLst>
            </p:cNvPr>
            <p:cNvSpPr txBox="1"/>
            <p:nvPr/>
          </p:nvSpPr>
          <p:spPr>
            <a:xfrm>
              <a:off x="4056684" y="7317257"/>
              <a:ext cx="1252165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dirty="0"/>
                <a:t>Control</a:t>
              </a:r>
              <a:endParaRPr lang="zh-CN" altLang="en-US" sz="1050" dirty="0"/>
            </a:p>
          </p:txBody>
        </p:sp>
      </p:grpSp>
      <p:pic>
        <p:nvPicPr>
          <p:cNvPr id="8" name="图片 7">
            <a:extLst>
              <a:ext uri="{FF2B5EF4-FFF2-40B4-BE49-F238E27FC236}">
                <a16:creationId xmlns:a16="http://schemas.microsoft.com/office/drawing/2014/main" id="{5220162C-A2AE-4452-A212-D93E4D98EC1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2648" r="6174"/>
          <a:stretch/>
        </p:blipFill>
        <p:spPr>
          <a:xfrm>
            <a:off x="342901" y="1100517"/>
            <a:ext cx="5791200" cy="60087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7642308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94636225"/>
              </p:ext>
            </p:extLst>
          </p:nvPr>
        </p:nvGraphicFramePr>
        <p:xfrm>
          <a:off x="495118" y="1121561"/>
          <a:ext cx="5735864" cy="7695866"/>
        </p:xfrm>
        <a:graphic>
          <a:graphicData uri="http://schemas.openxmlformats.org/drawingml/2006/table">
            <a:tbl>
              <a:tblPr/>
              <a:tblGrid>
                <a:gridCol w="1433966">
                  <a:extLst>
                    <a:ext uri="{9D8B030D-6E8A-4147-A177-3AD203B41FA5}">
                      <a16:colId xmlns:a16="http://schemas.microsoft.com/office/drawing/2014/main" val="4162690351"/>
                    </a:ext>
                  </a:extLst>
                </a:gridCol>
                <a:gridCol w="1433966">
                  <a:extLst>
                    <a:ext uri="{9D8B030D-6E8A-4147-A177-3AD203B41FA5}">
                      <a16:colId xmlns:a16="http://schemas.microsoft.com/office/drawing/2014/main" val="593321705"/>
                    </a:ext>
                  </a:extLst>
                </a:gridCol>
                <a:gridCol w="1433966">
                  <a:extLst>
                    <a:ext uri="{9D8B030D-6E8A-4147-A177-3AD203B41FA5}">
                      <a16:colId xmlns:a16="http://schemas.microsoft.com/office/drawing/2014/main" val="747697316"/>
                    </a:ext>
                  </a:extLst>
                </a:gridCol>
                <a:gridCol w="1433966">
                  <a:extLst>
                    <a:ext uri="{9D8B030D-6E8A-4147-A177-3AD203B41FA5}">
                      <a16:colId xmlns:a16="http://schemas.microsoft.com/office/drawing/2014/main" val="2879008068"/>
                    </a:ext>
                  </a:extLst>
                </a:gridCol>
              </a:tblGrid>
              <a:tr h="226349"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050" b="1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Negative Ion Mode</a:t>
                      </a:r>
                    </a:p>
                  </a:txBody>
                  <a:tcPr marL="6897" marR="6897" marT="68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14580696"/>
                  </a:ext>
                </a:extLst>
              </a:tr>
              <a:tr h="22634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9:0 Lyso PC（-）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7:0 PE（-）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9:0 PC（-）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2:0 SM (d18:1/12:0)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76662554"/>
                  </a:ext>
                </a:extLst>
              </a:tr>
              <a:tr h="22634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4:0 Lyso PC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5:0 Lyso PC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6:0 Lyso PC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7:0 Lyso PC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92546078"/>
                  </a:ext>
                </a:extLst>
              </a:tr>
              <a:tr h="22634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8:0 Lyso PC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8:1 Lyso PC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0:0 Lyso PC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2:0 Lyso PC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11943598"/>
                  </a:ext>
                </a:extLst>
              </a:tr>
              <a:tr h="22634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4:0 Lyso PC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6:0 Lyso PC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3:0 Lyso PI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6:0 Lyso PI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68261484"/>
                  </a:ext>
                </a:extLst>
              </a:tr>
              <a:tr h="22634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8:0 Lyso PI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8:1 Lyso PI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0:4 Lyso PI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4:0 PE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52318647"/>
                  </a:ext>
                </a:extLst>
              </a:tr>
              <a:tr h="22634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5:0 PE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6:0 PE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8:0 PE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6:0-18:1 PE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86630793"/>
                  </a:ext>
                </a:extLst>
              </a:tr>
              <a:tr h="22634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6:0-18:2 PE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6:0-20:4 PE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6:0-22:6 PE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8:0-18:1 PE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25522373"/>
                  </a:ext>
                </a:extLst>
              </a:tr>
              <a:tr h="22634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8:0-18:2 PE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8:0-20:4 PE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8:0-22:6 PE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8:0 Lyso PE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83050413"/>
                  </a:ext>
                </a:extLst>
              </a:tr>
              <a:tr h="22634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8:1 Lyso PE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4:0 PC (DMPC)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5:0 PC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6:0 PC (DPPC)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6154008"/>
                  </a:ext>
                </a:extLst>
              </a:tr>
              <a:tr h="22634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7:0 PC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8:0 PC (DSPC)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0:0 PC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1:0 PC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18032221"/>
                  </a:ext>
                </a:extLst>
              </a:tr>
              <a:tr h="22634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6:1 (Î”9-Cis) PC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8:2 (Cis) PC (DLPC)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8:3 (Cis) PC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0:1 (Cis) PC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35643107"/>
                  </a:ext>
                </a:extLst>
              </a:tr>
              <a:tr h="22634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0:4 (Cis) PC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6:0-18:1 PC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8:0-20:4 PC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8:0-22:6 PC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29638241"/>
                  </a:ext>
                </a:extLst>
              </a:tr>
              <a:tr h="22634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8:1-14:0 PC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8:1-18:0 PC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2:0 SM (d18:1/2:0)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6:0 SM (d18:1/16:0)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9838696"/>
                  </a:ext>
                </a:extLst>
              </a:tr>
              <a:tr h="22634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7:0 SM (d18:1/17:0)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8:0 SM (d18:1/18:0)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8:1SM(d18:1/18:1(9Z))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4:0 SM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0965949"/>
                  </a:ext>
                </a:extLst>
              </a:tr>
              <a:tr h="22634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4:1 SM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6:0 ceramide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8:0 ceramide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0:0 ceramide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17851293"/>
                  </a:ext>
                </a:extLst>
              </a:tr>
              <a:tr h="22634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2:0 ceramide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4:0 ceramide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4:1 ceramide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6897" marR="6897" marT="68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4486525"/>
                  </a:ext>
                </a:extLst>
              </a:tr>
              <a:tr h="226349"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050" b="1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Positive Ion Mode</a:t>
                      </a:r>
                    </a:p>
                  </a:txBody>
                  <a:tcPr marL="6897" marR="6897" marT="68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1760264"/>
                  </a:ext>
                </a:extLst>
              </a:tr>
              <a:tr h="22634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9:0 Lyso PC（+）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7:0 PE（+）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9:0 PC（+）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2:0 SM (d18:1/12:0)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40320387"/>
                  </a:ext>
                </a:extLst>
              </a:tr>
              <a:tr h="22634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3:0 Lyso PC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4:0 Lyso PC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5:0 Lyso PC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6:0 Lyso PC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99547301"/>
                  </a:ext>
                </a:extLst>
              </a:tr>
              <a:tr h="22634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7:0 Lyso PC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8:0 Lyso PC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8:1 Lyso PC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0:0 Lyso PC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3178505"/>
                  </a:ext>
                </a:extLst>
              </a:tr>
              <a:tr h="22634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2:0 Lyso PC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4:0 Lyso PC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6:0 Lyso PC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8:0 Lyso PI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3569238"/>
                  </a:ext>
                </a:extLst>
              </a:tr>
              <a:tr h="22634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7:1 Lyso PI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8:1 Lyso PI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0:4 Lyso PI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6:0 PE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6492775"/>
                  </a:ext>
                </a:extLst>
              </a:tr>
              <a:tr h="22634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8:0 PE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6:0-18:1 PE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6:0-18:2 PE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6:0-20:4 PE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11172115"/>
                  </a:ext>
                </a:extLst>
              </a:tr>
              <a:tr h="22634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6:0-22:6 PE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8:0-18:1 PE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8:0-18:2 PE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8:0-20:4 PE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80339853"/>
                  </a:ext>
                </a:extLst>
              </a:tr>
              <a:tr h="22634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8:0-22:6 PE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6:0 Lyso PE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8:0 Lyso PE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8:1 Lyso PE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94781450"/>
                  </a:ext>
                </a:extLst>
              </a:tr>
              <a:tr h="22634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5:0 PC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6:0 PC (DPPC)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7:0 PC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8:0 PC (DSPC)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9902399"/>
                  </a:ext>
                </a:extLst>
              </a:tr>
              <a:tr h="22634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6:1 (Î”9-Trans) PC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8:1 (Î”6-Cis) PC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8:2 (Cis) PC (DLPC)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0:1 (Cis) PC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38818489"/>
                  </a:ext>
                </a:extLst>
              </a:tr>
              <a:tr h="22634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0:4 (Cis) PC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6:0-18:1 PC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8:0-18:2 PC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8:0-20:4 PC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45830112"/>
                  </a:ext>
                </a:extLst>
              </a:tr>
              <a:tr h="22634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8:0-22:6 PC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8:1-14:0 PC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8:1-18:0 PC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2:0 SM (d18:1/2:0)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044651"/>
                  </a:ext>
                </a:extLst>
              </a:tr>
              <a:tr h="22634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6:0 SM (d18:1/16:0)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7:0 SM (d18:1/17:0)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8:0 SM (d18:1/18:0)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8:1SM(d18:1/18:1(9Z))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11661189"/>
                  </a:ext>
                </a:extLst>
              </a:tr>
              <a:tr h="22634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4:0 SM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4:1 SM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6:0 ceramide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8:0 ceramide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8567109"/>
                  </a:ext>
                </a:extLst>
              </a:tr>
              <a:tr h="22634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8:1 ceramide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9:0 ceramide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0:0 ceramide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2:0 ceramide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33561145"/>
                  </a:ext>
                </a:extLst>
              </a:tr>
              <a:tr h="22634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4:0 ceramide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24:1 ceramide</a:t>
                      </a:r>
                    </a:p>
                  </a:txBody>
                  <a:tcPr marL="6897" marR="6897" marT="689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105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6897" marR="6897" marT="68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alt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6897" marR="6897" marT="689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79860769"/>
                  </a:ext>
                </a:extLst>
              </a:tr>
            </a:tbl>
          </a:graphicData>
        </a:graphic>
      </p:graphicFrame>
      <p:sp>
        <p:nvSpPr>
          <p:cNvPr id="3" name="Textfeld 19"/>
          <p:cNvSpPr txBox="1"/>
          <p:nvPr/>
        </p:nvSpPr>
        <p:spPr>
          <a:xfrm>
            <a:off x="351426" y="374385"/>
            <a:ext cx="602324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altLang="zh-CN" b="1"/>
              <a:t>Supplementary Table S1</a:t>
            </a:r>
            <a:r>
              <a:rPr lang="de-DE" altLang="zh-CN"/>
              <a:t> </a:t>
            </a:r>
            <a:r>
              <a:rPr lang="de-DE" altLang="zh-CN" dirty="0"/>
              <a:t>List of </a:t>
            </a:r>
            <a:r>
              <a:rPr lang="en-US" altLang="zh-CN" dirty="0"/>
              <a:t>lipids</a:t>
            </a:r>
            <a:r>
              <a:rPr lang="de-DE" altLang="zh-CN" dirty="0"/>
              <a:t> being tested by negative and positive ion mode </a:t>
            </a:r>
          </a:p>
        </p:txBody>
      </p:sp>
    </p:spTree>
    <p:extLst>
      <p:ext uri="{BB962C8B-B14F-4D97-AF65-F5344CB8AC3E}">
        <p14:creationId xmlns:p14="http://schemas.microsoft.com/office/powerpoint/2010/main" val="28843433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141</TotalTime>
  <Words>456</Words>
  <Application>Microsoft Office PowerPoint</Application>
  <PresentationFormat>A4 纸张(210x297 毫米)</PresentationFormat>
  <Paragraphs>141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0" baseType="lpstr">
      <vt:lpstr>等线</vt:lpstr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he jianqing</dc:creator>
  <cp:lastModifiedBy>折剑青</cp:lastModifiedBy>
  <cp:revision>67</cp:revision>
  <dcterms:created xsi:type="dcterms:W3CDTF">2018-04-26T02:49:03Z</dcterms:created>
  <dcterms:modified xsi:type="dcterms:W3CDTF">2019-03-04T02:08:11Z</dcterms:modified>
</cp:coreProperties>
</file>